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56" r:id="rId2"/>
  </p:sldIdLst>
  <p:sldSz cx="6858000" cy="9144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43"/>
    <p:restoredTop sz="94643"/>
  </p:normalViewPr>
  <p:slideViewPr>
    <p:cSldViewPr snapToGrid="0" snapToObjects="1" showGuides="1">
      <p:cViewPr varScale="1">
        <p:scale>
          <a:sx n="80" d="100"/>
          <a:sy n="80" d="100"/>
        </p:scale>
        <p:origin x="3084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SUKAHARA-iMAC\Documents\138th%20paper%20(&#20581;&#24120;&#35930;&#20869;&#23481;&#29289;&#65295;&#31896;&#33180;&#33740;&#21474;)\Resubmit%20Baysian\alpha%20diversity%20&#20877;&#35336;&#31639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SUKAHARA-iMAC\Documents\138th%20paper%20(&#20581;&#24120;&#35930;&#20869;&#23481;&#29289;&#65295;&#31896;&#33180;&#33740;&#21474;)\weighted%20PCoA%20distance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TSUKAHARA-iMAC\Documents\138th%20paper%20(&#20581;&#24120;&#35930;&#20869;&#23481;&#29289;&#65295;&#31896;&#33180;&#33740;&#21474;)\Resubmit%20Baysian\alpha%20diversity%20&#20877;&#35336;&#31639;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lpha_div!$M$1</c:f>
              <c:strCache>
                <c:ptCount val="1"/>
                <c:pt idx="0">
                  <c:v>chao1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F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493F-6A4E-91A9-6D2F18608317}"/>
              </c:ext>
            </c:extLst>
          </c:dPt>
          <c:dPt>
            <c:idx val="1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493F-6A4E-91A9-6D2F18608317}"/>
              </c:ext>
            </c:extLst>
          </c:dPt>
          <c:dPt>
            <c:idx val="2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493F-6A4E-91A9-6D2F18608317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493F-6A4E-91A9-6D2F18608317}"/>
              </c:ext>
            </c:extLst>
          </c:dPt>
          <c:dPt>
            <c:idx val="4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493F-6A4E-91A9-6D2F18608317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493F-6A4E-91A9-6D2F18608317}"/>
              </c:ext>
            </c:extLst>
          </c:dPt>
          <c:dPt>
            <c:idx val="6"/>
            <c:invertIfNegative val="0"/>
            <c:bubble3D val="0"/>
            <c:spPr>
              <a:solidFill>
                <a:srgbClr val="FFFF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493F-6A4E-91A9-6D2F18608317}"/>
              </c:ext>
            </c:extLst>
          </c:dPt>
          <c:dPt>
            <c:idx val="7"/>
            <c:invertIfNegative val="0"/>
            <c:bubble3D val="0"/>
            <c:spPr>
              <a:solidFill>
                <a:srgbClr val="00B0F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493F-6A4E-91A9-6D2F18608317}"/>
              </c:ext>
            </c:extLst>
          </c:dPt>
          <c:dPt>
            <c:idx val="8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493F-6A4E-91A9-6D2F18608317}"/>
              </c:ext>
            </c:extLst>
          </c:dPt>
          <c:dPt>
            <c:idx val="9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493F-6A4E-91A9-6D2F18608317}"/>
              </c:ext>
            </c:extLst>
          </c:dPt>
          <c:dPt>
            <c:idx val="10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493F-6A4E-91A9-6D2F18608317}"/>
              </c:ext>
            </c:extLst>
          </c:dPt>
          <c:dPt>
            <c:idx val="11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493F-6A4E-91A9-6D2F18608317}"/>
              </c:ext>
            </c:extLst>
          </c:dPt>
          <c:dPt>
            <c:idx val="1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493F-6A4E-91A9-6D2F18608317}"/>
              </c:ext>
            </c:extLst>
          </c:dPt>
          <c:dPt>
            <c:idx val="13"/>
            <c:invertIfNegative val="0"/>
            <c:bubble3D val="0"/>
            <c:spPr>
              <a:solidFill>
                <a:srgbClr val="FFFF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493F-6A4E-91A9-6D2F18608317}"/>
              </c:ext>
            </c:extLst>
          </c:dPt>
          <c:errBars>
            <c:errBarType val="plus"/>
            <c:errValType val="cust"/>
            <c:noEndCap val="0"/>
            <c:plus>
              <c:numRef>
                <c:f>Alpha_div!$M$18:$M$31</c:f>
                <c:numCache>
                  <c:formatCode>General</c:formatCode>
                  <c:ptCount val="14"/>
                  <c:pt idx="0">
                    <c:v>56.333483935805752</c:v>
                  </c:pt>
                  <c:pt idx="1">
                    <c:v>45.956132779920303</c:v>
                  </c:pt>
                  <c:pt idx="2">
                    <c:v>35.551997067181127</c:v>
                  </c:pt>
                  <c:pt idx="3">
                    <c:v>29.824020985116604</c:v>
                  </c:pt>
                  <c:pt idx="4">
                    <c:v>42.270355057258115</c:v>
                  </c:pt>
                  <c:pt idx="5">
                    <c:v>45.612326204410635</c:v>
                  </c:pt>
                  <c:pt idx="6">
                    <c:v>33.82155829414959</c:v>
                  </c:pt>
                  <c:pt idx="7">
                    <c:v>14.685257577702101</c:v>
                  </c:pt>
                  <c:pt idx="8">
                    <c:v>20.306609829752023</c:v>
                  </c:pt>
                  <c:pt idx="9">
                    <c:v>41.040359539252471</c:v>
                  </c:pt>
                  <c:pt idx="10">
                    <c:v>32.216589545997991</c:v>
                  </c:pt>
                  <c:pt idx="11">
                    <c:v>66.461350506223638</c:v>
                  </c:pt>
                  <c:pt idx="12">
                    <c:v>29.979553217336502</c:v>
                  </c:pt>
                  <c:pt idx="13">
                    <c:v>31.6363725708944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Alpha_div!$J$2:$K$15</c:f>
              <c:multiLvlStrCache>
                <c:ptCount val="14"/>
                <c:lvl>
                  <c:pt idx="0">
                    <c:v>St</c:v>
                  </c:pt>
                  <c:pt idx="1">
                    <c:v>Je</c:v>
                  </c:pt>
                  <c:pt idx="2">
                    <c:v>IL</c:v>
                  </c:pt>
                  <c:pt idx="3">
                    <c:v>Ce</c:v>
                  </c:pt>
                  <c:pt idx="4">
                    <c:v>PC</c:v>
                  </c:pt>
                  <c:pt idx="5">
                    <c:v>DC</c:v>
                  </c:pt>
                  <c:pt idx="6">
                    <c:v>Re</c:v>
                  </c:pt>
                  <c:pt idx="7">
                    <c:v>St</c:v>
                  </c:pt>
                  <c:pt idx="8">
                    <c:v>Je</c:v>
                  </c:pt>
                  <c:pt idx="9">
                    <c:v>IL</c:v>
                  </c:pt>
                  <c:pt idx="10">
                    <c:v>Ce</c:v>
                  </c:pt>
                  <c:pt idx="11">
                    <c:v>PC</c:v>
                  </c:pt>
                  <c:pt idx="12">
                    <c:v>DC</c:v>
                  </c:pt>
                  <c:pt idx="13">
                    <c:v>Re</c:v>
                  </c:pt>
                </c:lvl>
                <c:lvl>
                  <c:pt idx="0">
                    <c:v>Mucosa</c:v>
                  </c:pt>
                  <c:pt idx="7">
                    <c:v>Digesta</c:v>
                  </c:pt>
                </c:lvl>
              </c:multiLvlStrCache>
            </c:multiLvlStrRef>
          </c:cat>
          <c:val>
            <c:numRef>
              <c:f>Alpha_div!$M$2:$M$15</c:f>
              <c:numCache>
                <c:formatCode>General</c:formatCode>
                <c:ptCount val="14"/>
                <c:pt idx="0">
                  <c:v>238.37555555555537</c:v>
                </c:pt>
                <c:pt idx="1">
                  <c:v>311.17936507936497</c:v>
                </c:pt>
                <c:pt idx="2">
                  <c:v>303.82619047619016</c:v>
                </c:pt>
                <c:pt idx="3">
                  <c:v>351.24765512265481</c:v>
                </c:pt>
                <c:pt idx="4">
                  <c:v>263.22499999999997</c:v>
                </c:pt>
                <c:pt idx="5">
                  <c:v>322.05448343079917</c:v>
                </c:pt>
                <c:pt idx="6">
                  <c:v>362.34990379990364</c:v>
                </c:pt>
                <c:pt idx="7">
                  <c:v>365.44444444444434</c:v>
                </c:pt>
                <c:pt idx="8">
                  <c:v>392.24166666666662</c:v>
                </c:pt>
                <c:pt idx="9">
                  <c:v>182.16666666666666</c:v>
                </c:pt>
                <c:pt idx="10">
                  <c:v>401.75555555555547</c:v>
                </c:pt>
                <c:pt idx="11">
                  <c:v>149.33333333333334</c:v>
                </c:pt>
                <c:pt idx="12">
                  <c:v>99.916666666666671</c:v>
                </c:pt>
                <c:pt idx="13">
                  <c:v>427.2083333333333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93F-6A4E-91A9-6D2F1860831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11328176"/>
        <c:axId val="411853152"/>
      </c:barChart>
      <c:catAx>
        <c:axId val="4113281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1853152"/>
        <c:crosses val="autoZero"/>
        <c:auto val="1"/>
        <c:lblAlgn val="ctr"/>
        <c:lblOffset val="100"/>
        <c:noMultiLvlLbl val="0"/>
      </c:catAx>
      <c:valAx>
        <c:axId val="4118531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13281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1.2557655797348098E-2"/>
          <c:y val="5.3901076398816189E-3"/>
          <c:w val="0.96660184407784766"/>
          <c:h val="0.97841020608439644"/>
        </c:manualLayout>
      </c:layout>
      <c:scatterChart>
        <c:scatterStyle val="lineMarker"/>
        <c:varyColors val="0"/>
        <c:ser>
          <c:idx val="0"/>
          <c:order val="0"/>
          <c:tx>
            <c:strRef>
              <c:f>'weighted_unifrac_pcoa_resul (2)'!$C$9</c:f>
              <c:strCache>
                <c:ptCount val="1"/>
                <c:pt idx="0">
                  <c:v>PC2</c:v>
                </c:pt>
              </c:strCache>
            </c:strRef>
          </c:tx>
          <c:spPr>
            <a:ln w="1905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dPt>
            <c:idx val="0"/>
            <c:marker>
              <c:symbol val="triangle"/>
              <c:size val="9"/>
              <c:spPr>
                <a:solidFill>
                  <a:srgbClr val="7030A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0-8C29-5040-9158-0BE499FF9603}"/>
              </c:ext>
            </c:extLst>
          </c:dPt>
          <c:dPt>
            <c:idx val="1"/>
            <c:marker>
              <c:symbol val="triangle"/>
              <c:size val="9"/>
              <c:spPr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1-8C29-5040-9158-0BE499FF9603}"/>
              </c:ext>
            </c:extLst>
          </c:dPt>
          <c:dPt>
            <c:idx val="2"/>
            <c:marker>
              <c:symbol val="triangle"/>
              <c:size val="9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2-8C29-5040-9158-0BE499FF9603}"/>
              </c:ext>
            </c:extLst>
          </c:dPt>
          <c:dPt>
            <c:idx val="3"/>
            <c:marker>
              <c:symbol val="triangle"/>
              <c:size val="9"/>
              <c:spPr>
                <a:solidFill>
                  <a:srgbClr val="FFFF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3-8C29-5040-9158-0BE499FF9603}"/>
              </c:ext>
            </c:extLst>
          </c:dPt>
          <c:dPt>
            <c:idx val="4"/>
            <c:marker>
              <c:symbol val="triangle"/>
              <c:size val="9"/>
              <c:spPr>
                <a:solidFill>
                  <a:srgbClr val="00B0F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4-8C29-5040-9158-0BE499FF9603}"/>
              </c:ext>
            </c:extLst>
          </c:dPt>
          <c:dPt>
            <c:idx val="5"/>
            <c:marker>
              <c:symbol val="triangle"/>
              <c:size val="9"/>
              <c:spPr>
                <a:solidFill>
                  <a:srgbClr val="92D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5-8C29-5040-9158-0BE499FF9603}"/>
              </c:ext>
            </c:extLst>
          </c:dPt>
          <c:dPt>
            <c:idx val="6"/>
            <c:marker>
              <c:symbol val="triangle"/>
              <c:size val="9"/>
              <c:spPr>
                <a:solidFill>
                  <a:srgbClr val="FFC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6-8C29-5040-9158-0BE499FF9603}"/>
              </c:ext>
            </c:extLst>
          </c:dPt>
          <c:dPt>
            <c:idx val="7"/>
            <c:marker>
              <c:symbol val="triangle"/>
              <c:size val="9"/>
              <c:spPr>
                <a:solidFill>
                  <a:srgbClr val="7030A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7-8C29-5040-9158-0BE499FF9603}"/>
              </c:ext>
            </c:extLst>
          </c:dPt>
          <c:dPt>
            <c:idx val="8"/>
            <c:marker>
              <c:symbol val="triangle"/>
              <c:size val="9"/>
              <c:spPr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8-8C29-5040-9158-0BE499FF9603}"/>
              </c:ext>
            </c:extLst>
          </c:dPt>
          <c:dPt>
            <c:idx val="9"/>
            <c:marker>
              <c:symbol val="triangle"/>
              <c:size val="9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9-8C29-5040-9158-0BE499FF9603}"/>
              </c:ext>
            </c:extLst>
          </c:dPt>
          <c:dPt>
            <c:idx val="10"/>
            <c:marker>
              <c:symbol val="triangle"/>
              <c:size val="9"/>
              <c:spPr>
                <a:solidFill>
                  <a:srgbClr val="FFFF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A-8C29-5040-9158-0BE499FF9603}"/>
              </c:ext>
            </c:extLst>
          </c:dPt>
          <c:dPt>
            <c:idx val="11"/>
            <c:marker>
              <c:symbol val="triangle"/>
              <c:size val="9"/>
              <c:spPr>
                <a:solidFill>
                  <a:srgbClr val="00B0F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B-8C29-5040-9158-0BE499FF9603}"/>
              </c:ext>
            </c:extLst>
          </c:dPt>
          <c:dPt>
            <c:idx val="12"/>
            <c:marker>
              <c:symbol val="triangle"/>
              <c:size val="9"/>
              <c:spPr>
                <a:solidFill>
                  <a:srgbClr val="92D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C-8C29-5040-9158-0BE499FF9603}"/>
              </c:ext>
            </c:extLst>
          </c:dPt>
          <c:dPt>
            <c:idx val="13"/>
            <c:marker>
              <c:symbol val="triangle"/>
              <c:size val="9"/>
              <c:spPr>
                <a:solidFill>
                  <a:srgbClr val="FFC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D-8C29-5040-9158-0BE499FF9603}"/>
              </c:ext>
            </c:extLst>
          </c:dPt>
          <c:dPt>
            <c:idx val="14"/>
            <c:marker>
              <c:symbol val="triangle"/>
              <c:size val="9"/>
              <c:spPr>
                <a:solidFill>
                  <a:srgbClr val="7030A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E-8C29-5040-9158-0BE499FF9603}"/>
              </c:ext>
            </c:extLst>
          </c:dPt>
          <c:dPt>
            <c:idx val="15"/>
            <c:marker>
              <c:symbol val="triangle"/>
              <c:size val="9"/>
              <c:spPr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0F-8C29-5040-9158-0BE499FF9603}"/>
              </c:ext>
            </c:extLst>
          </c:dPt>
          <c:dPt>
            <c:idx val="16"/>
            <c:marker>
              <c:symbol val="triangle"/>
              <c:size val="9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0-8C29-5040-9158-0BE499FF9603}"/>
              </c:ext>
            </c:extLst>
          </c:dPt>
          <c:dPt>
            <c:idx val="17"/>
            <c:marker>
              <c:symbol val="triangle"/>
              <c:size val="9"/>
              <c:spPr>
                <a:solidFill>
                  <a:srgbClr val="FFFF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1-8C29-5040-9158-0BE499FF9603}"/>
              </c:ext>
            </c:extLst>
          </c:dPt>
          <c:dPt>
            <c:idx val="18"/>
            <c:marker>
              <c:symbol val="triangle"/>
              <c:size val="9"/>
              <c:spPr>
                <a:solidFill>
                  <a:srgbClr val="00B0F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2-8C29-5040-9158-0BE499FF9603}"/>
              </c:ext>
            </c:extLst>
          </c:dPt>
          <c:dPt>
            <c:idx val="19"/>
            <c:marker>
              <c:symbol val="triangle"/>
              <c:size val="9"/>
              <c:spPr>
                <a:solidFill>
                  <a:srgbClr val="92D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3-8C29-5040-9158-0BE499FF9603}"/>
              </c:ext>
            </c:extLst>
          </c:dPt>
          <c:dPt>
            <c:idx val="20"/>
            <c:marker>
              <c:symbol val="triangle"/>
              <c:size val="9"/>
              <c:spPr>
                <a:solidFill>
                  <a:srgbClr val="FFC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4-8C29-5040-9158-0BE499FF9603}"/>
              </c:ext>
            </c:extLst>
          </c:dPt>
          <c:dPt>
            <c:idx val="21"/>
            <c:marker>
              <c:symbol val="triangle"/>
              <c:size val="9"/>
              <c:spPr>
                <a:solidFill>
                  <a:srgbClr val="7030A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5-8C29-5040-9158-0BE499FF9603}"/>
              </c:ext>
            </c:extLst>
          </c:dPt>
          <c:dPt>
            <c:idx val="22"/>
            <c:marker>
              <c:symbol val="triangle"/>
              <c:size val="9"/>
              <c:spPr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6-8C29-5040-9158-0BE499FF9603}"/>
              </c:ext>
            </c:extLst>
          </c:dPt>
          <c:dPt>
            <c:idx val="23"/>
            <c:marker>
              <c:symbol val="triangle"/>
              <c:size val="9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7-8C29-5040-9158-0BE499FF9603}"/>
              </c:ext>
            </c:extLst>
          </c:dPt>
          <c:dPt>
            <c:idx val="24"/>
            <c:marker>
              <c:symbol val="triangle"/>
              <c:size val="9"/>
              <c:spPr>
                <a:solidFill>
                  <a:srgbClr val="FFFF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8-8C29-5040-9158-0BE499FF9603}"/>
              </c:ext>
            </c:extLst>
          </c:dPt>
          <c:dPt>
            <c:idx val="25"/>
            <c:marker>
              <c:symbol val="triangle"/>
              <c:size val="9"/>
              <c:spPr>
                <a:solidFill>
                  <a:srgbClr val="00B0F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9-8C29-5040-9158-0BE499FF9603}"/>
              </c:ext>
            </c:extLst>
          </c:dPt>
          <c:dPt>
            <c:idx val="26"/>
            <c:marker>
              <c:symbol val="triangle"/>
              <c:size val="9"/>
              <c:spPr>
                <a:solidFill>
                  <a:srgbClr val="92D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A-8C29-5040-9158-0BE499FF9603}"/>
              </c:ext>
            </c:extLst>
          </c:dPt>
          <c:dPt>
            <c:idx val="27"/>
            <c:marker>
              <c:symbol val="triangle"/>
              <c:size val="9"/>
              <c:spPr>
                <a:solidFill>
                  <a:srgbClr val="FFC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B-8C29-5040-9158-0BE499FF9603}"/>
              </c:ext>
            </c:extLst>
          </c:dPt>
          <c:dPt>
            <c:idx val="28"/>
            <c:marker>
              <c:symbol val="triangle"/>
              <c:size val="9"/>
              <c:spPr>
                <a:solidFill>
                  <a:srgbClr val="7030A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C-8C29-5040-9158-0BE499FF9603}"/>
              </c:ext>
            </c:extLst>
          </c:dPt>
          <c:dPt>
            <c:idx val="29"/>
            <c:marker>
              <c:symbol val="triangle"/>
              <c:size val="9"/>
              <c:spPr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D-8C29-5040-9158-0BE499FF9603}"/>
              </c:ext>
            </c:extLst>
          </c:dPt>
          <c:dPt>
            <c:idx val="30"/>
            <c:marker>
              <c:symbol val="triangle"/>
              <c:size val="9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E-8C29-5040-9158-0BE499FF9603}"/>
              </c:ext>
            </c:extLst>
          </c:dPt>
          <c:dPt>
            <c:idx val="31"/>
            <c:marker>
              <c:symbol val="triangle"/>
              <c:size val="9"/>
              <c:spPr>
                <a:solidFill>
                  <a:srgbClr val="FFFF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1F-8C29-5040-9158-0BE499FF9603}"/>
              </c:ext>
            </c:extLst>
          </c:dPt>
          <c:dPt>
            <c:idx val="32"/>
            <c:marker>
              <c:symbol val="triangle"/>
              <c:size val="9"/>
              <c:spPr>
                <a:solidFill>
                  <a:srgbClr val="00B0F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0-8C29-5040-9158-0BE499FF9603}"/>
              </c:ext>
            </c:extLst>
          </c:dPt>
          <c:dPt>
            <c:idx val="33"/>
            <c:marker>
              <c:symbol val="triangle"/>
              <c:size val="9"/>
              <c:spPr>
                <a:solidFill>
                  <a:srgbClr val="92D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1-8C29-5040-9158-0BE499FF9603}"/>
              </c:ext>
            </c:extLst>
          </c:dPt>
          <c:dPt>
            <c:idx val="34"/>
            <c:marker>
              <c:symbol val="triangle"/>
              <c:size val="9"/>
              <c:spPr>
                <a:solidFill>
                  <a:srgbClr val="FFC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2-8C29-5040-9158-0BE499FF9603}"/>
              </c:ext>
            </c:extLst>
          </c:dPt>
          <c:dPt>
            <c:idx val="35"/>
            <c:marker>
              <c:symbol val="triangle"/>
              <c:size val="9"/>
              <c:spPr>
                <a:solidFill>
                  <a:srgbClr val="7030A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3-8C29-5040-9158-0BE499FF9603}"/>
              </c:ext>
            </c:extLst>
          </c:dPt>
          <c:dPt>
            <c:idx val="36"/>
            <c:marker>
              <c:symbol val="triangle"/>
              <c:size val="9"/>
              <c:spPr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4-8C29-5040-9158-0BE499FF9603}"/>
              </c:ext>
            </c:extLst>
          </c:dPt>
          <c:dPt>
            <c:idx val="37"/>
            <c:marker>
              <c:symbol val="triangle"/>
              <c:size val="9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5-8C29-5040-9158-0BE499FF9603}"/>
              </c:ext>
            </c:extLst>
          </c:dPt>
          <c:dPt>
            <c:idx val="38"/>
            <c:marker>
              <c:symbol val="triangle"/>
              <c:size val="9"/>
              <c:spPr>
                <a:solidFill>
                  <a:srgbClr val="FFFF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6-8C29-5040-9158-0BE499FF9603}"/>
              </c:ext>
            </c:extLst>
          </c:dPt>
          <c:dPt>
            <c:idx val="39"/>
            <c:marker>
              <c:symbol val="triangle"/>
              <c:size val="9"/>
              <c:spPr>
                <a:solidFill>
                  <a:srgbClr val="00B0F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7-8C29-5040-9158-0BE499FF9603}"/>
              </c:ext>
            </c:extLst>
          </c:dPt>
          <c:dPt>
            <c:idx val="40"/>
            <c:marker>
              <c:symbol val="triangle"/>
              <c:size val="9"/>
              <c:spPr>
                <a:solidFill>
                  <a:srgbClr val="92D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8-8C29-5040-9158-0BE499FF9603}"/>
              </c:ext>
            </c:extLst>
          </c:dPt>
          <c:dPt>
            <c:idx val="41"/>
            <c:marker>
              <c:symbol val="triangle"/>
              <c:size val="9"/>
              <c:spPr>
                <a:solidFill>
                  <a:srgbClr val="FFC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9-8C29-5040-9158-0BE499FF9603}"/>
              </c:ext>
            </c:extLst>
          </c:dPt>
          <c:dPt>
            <c:idx val="42"/>
            <c:marker>
              <c:symbol val="circle"/>
              <c:size val="9"/>
              <c:spPr>
                <a:solidFill>
                  <a:srgbClr val="7030A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A-8C29-5040-9158-0BE499FF9603}"/>
              </c:ext>
            </c:extLst>
          </c:dPt>
          <c:dPt>
            <c:idx val="43"/>
            <c:marker>
              <c:symbol val="circle"/>
              <c:size val="9"/>
              <c:spPr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B-8C29-5040-9158-0BE499FF9603}"/>
              </c:ext>
            </c:extLst>
          </c:dPt>
          <c:dPt>
            <c:idx val="44"/>
            <c:marker>
              <c:symbol val="circle"/>
              <c:size val="9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C-8C29-5040-9158-0BE499FF9603}"/>
              </c:ext>
            </c:extLst>
          </c:dPt>
          <c:dPt>
            <c:idx val="45"/>
            <c:marker>
              <c:symbol val="circle"/>
              <c:size val="9"/>
              <c:spPr>
                <a:solidFill>
                  <a:srgbClr val="FFFF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D-8C29-5040-9158-0BE499FF9603}"/>
              </c:ext>
            </c:extLst>
          </c:dPt>
          <c:dPt>
            <c:idx val="46"/>
            <c:marker>
              <c:symbol val="circle"/>
              <c:size val="9"/>
              <c:spPr>
                <a:solidFill>
                  <a:srgbClr val="00B0F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E-8C29-5040-9158-0BE499FF9603}"/>
              </c:ext>
            </c:extLst>
          </c:dPt>
          <c:dPt>
            <c:idx val="47"/>
            <c:marker>
              <c:symbol val="circle"/>
              <c:size val="9"/>
              <c:spPr>
                <a:solidFill>
                  <a:srgbClr val="92D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2F-8C29-5040-9158-0BE499FF9603}"/>
              </c:ext>
            </c:extLst>
          </c:dPt>
          <c:dPt>
            <c:idx val="48"/>
            <c:marker>
              <c:symbol val="circle"/>
              <c:size val="9"/>
              <c:spPr>
                <a:solidFill>
                  <a:srgbClr val="FFC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30-8C29-5040-9158-0BE499FF9603}"/>
              </c:ext>
            </c:extLst>
          </c:dPt>
          <c:dPt>
            <c:idx val="49"/>
            <c:marker>
              <c:symbol val="circle"/>
              <c:size val="9"/>
              <c:spPr>
                <a:solidFill>
                  <a:srgbClr val="7030A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31-8C29-5040-9158-0BE499FF9603}"/>
              </c:ext>
            </c:extLst>
          </c:dPt>
          <c:dPt>
            <c:idx val="50"/>
            <c:marker>
              <c:symbol val="circle"/>
              <c:size val="9"/>
              <c:spPr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32-8C29-5040-9158-0BE499FF9603}"/>
              </c:ext>
            </c:extLst>
          </c:dPt>
          <c:dPt>
            <c:idx val="51"/>
            <c:marker>
              <c:symbol val="circle"/>
              <c:size val="9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33-8C29-5040-9158-0BE499FF9603}"/>
              </c:ext>
            </c:extLst>
          </c:dPt>
          <c:dPt>
            <c:idx val="52"/>
            <c:marker>
              <c:symbol val="circle"/>
              <c:size val="9"/>
              <c:spPr>
                <a:solidFill>
                  <a:srgbClr val="FFFF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34-8C29-5040-9158-0BE499FF9603}"/>
              </c:ext>
            </c:extLst>
          </c:dPt>
          <c:dPt>
            <c:idx val="53"/>
            <c:marker>
              <c:symbol val="circle"/>
              <c:size val="9"/>
              <c:spPr>
                <a:solidFill>
                  <a:srgbClr val="00B0F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35-8C29-5040-9158-0BE499FF9603}"/>
              </c:ext>
            </c:extLst>
          </c:dPt>
          <c:dPt>
            <c:idx val="54"/>
            <c:marker>
              <c:symbol val="circle"/>
              <c:size val="9"/>
              <c:spPr>
                <a:solidFill>
                  <a:srgbClr val="92D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36-8C29-5040-9158-0BE499FF9603}"/>
              </c:ext>
            </c:extLst>
          </c:dPt>
          <c:dPt>
            <c:idx val="55"/>
            <c:marker>
              <c:symbol val="circle"/>
              <c:size val="9"/>
              <c:spPr>
                <a:solidFill>
                  <a:srgbClr val="FFC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37-8C29-5040-9158-0BE499FF9603}"/>
              </c:ext>
            </c:extLst>
          </c:dPt>
          <c:dPt>
            <c:idx val="56"/>
            <c:marker>
              <c:symbol val="circle"/>
              <c:size val="9"/>
              <c:spPr>
                <a:solidFill>
                  <a:srgbClr val="7030A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38-8C29-5040-9158-0BE499FF9603}"/>
              </c:ext>
            </c:extLst>
          </c:dPt>
          <c:dPt>
            <c:idx val="57"/>
            <c:marker>
              <c:symbol val="circle"/>
              <c:size val="9"/>
              <c:spPr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39-8C29-5040-9158-0BE499FF9603}"/>
              </c:ext>
            </c:extLst>
          </c:dPt>
          <c:dPt>
            <c:idx val="58"/>
            <c:marker>
              <c:symbol val="circle"/>
              <c:size val="9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3A-8C29-5040-9158-0BE499FF9603}"/>
              </c:ext>
            </c:extLst>
          </c:dPt>
          <c:dPt>
            <c:idx val="59"/>
            <c:marker>
              <c:symbol val="circle"/>
              <c:size val="9"/>
              <c:spPr>
                <a:solidFill>
                  <a:srgbClr val="FFFF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3B-8C29-5040-9158-0BE499FF9603}"/>
              </c:ext>
            </c:extLst>
          </c:dPt>
          <c:dPt>
            <c:idx val="60"/>
            <c:marker>
              <c:symbol val="circle"/>
              <c:size val="9"/>
              <c:spPr>
                <a:solidFill>
                  <a:srgbClr val="00B0F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3C-8C29-5040-9158-0BE499FF9603}"/>
              </c:ext>
            </c:extLst>
          </c:dPt>
          <c:dPt>
            <c:idx val="61"/>
            <c:marker>
              <c:symbol val="circle"/>
              <c:size val="9"/>
              <c:spPr>
                <a:solidFill>
                  <a:srgbClr val="92D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3D-8C29-5040-9158-0BE499FF9603}"/>
              </c:ext>
            </c:extLst>
          </c:dPt>
          <c:dPt>
            <c:idx val="62"/>
            <c:marker>
              <c:symbol val="circle"/>
              <c:size val="9"/>
              <c:spPr>
                <a:solidFill>
                  <a:srgbClr val="FFC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3E-8C29-5040-9158-0BE499FF9603}"/>
              </c:ext>
            </c:extLst>
          </c:dPt>
          <c:dPt>
            <c:idx val="63"/>
            <c:marker>
              <c:symbol val="circle"/>
              <c:size val="9"/>
              <c:spPr>
                <a:solidFill>
                  <a:srgbClr val="7030A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3F-8C29-5040-9158-0BE499FF9603}"/>
              </c:ext>
            </c:extLst>
          </c:dPt>
          <c:dPt>
            <c:idx val="64"/>
            <c:marker>
              <c:symbol val="circle"/>
              <c:size val="9"/>
              <c:spPr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40-8C29-5040-9158-0BE499FF9603}"/>
              </c:ext>
            </c:extLst>
          </c:dPt>
          <c:dPt>
            <c:idx val="65"/>
            <c:marker>
              <c:symbol val="circle"/>
              <c:size val="9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41-8C29-5040-9158-0BE499FF9603}"/>
              </c:ext>
            </c:extLst>
          </c:dPt>
          <c:dPt>
            <c:idx val="66"/>
            <c:marker>
              <c:symbol val="circle"/>
              <c:size val="9"/>
              <c:spPr>
                <a:solidFill>
                  <a:srgbClr val="FFFF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42-8C29-5040-9158-0BE499FF9603}"/>
              </c:ext>
            </c:extLst>
          </c:dPt>
          <c:dPt>
            <c:idx val="67"/>
            <c:marker>
              <c:symbol val="circle"/>
              <c:size val="9"/>
              <c:spPr>
                <a:solidFill>
                  <a:srgbClr val="00B0F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43-8C29-5040-9158-0BE499FF9603}"/>
              </c:ext>
            </c:extLst>
          </c:dPt>
          <c:dPt>
            <c:idx val="68"/>
            <c:marker>
              <c:symbol val="circle"/>
              <c:size val="9"/>
              <c:spPr>
                <a:solidFill>
                  <a:srgbClr val="92D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44-8C29-5040-9158-0BE499FF9603}"/>
              </c:ext>
            </c:extLst>
          </c:dPt>
          <c:dPt>
            <c:idx val="69"/>
            <c:marker>
              <c:symbol val="circle"/>
              <c:size val="9"/>
              <c:spPr>
                <a:solidFill>
                  <a:srgbClr val="FFC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45-8C29-5040-9158-0BE499FF9603}"/>
              </c:ext>
            </c:extLst>
          </c:dPt>
          <c:dPt>
            <c:idx val="70"/>
            <c:marker>
              <c:symbol val="circle"/>
              <c:size val="9"/>
              <c:spPr>
                <a:solidFill>
                  <a:srgbClr val="7030A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46-8C29-5040-9158-0BE499FF9603}"/>
              </c:ext>
            </c:extLst>
          </c:dPt>
          <c:dPt>
            <c:idx val="71"/>
            <c:marker>
              <c:symbol val="circle"/>
              <c:size val="9"/>
              <c:spPr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47-8C29-5040-9158-0BE499FF9603}"/>
              </c:ext>
            </c:extLst>
          </c:dPt>
          <c:dPt>
            <c:idx val="72"/>
            <c:marker>
              <c:symbol val="circle"/>
              <c:size val="9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48-8C29-5040-9158-0BE499FF9603}"/>
              </c:ext>
            </c:extLst>
          </c:dPt>
          <c:dPt>
            <c:idx val="73"/>
            <c:marker>
              <c:symbol val="circle"/>
              <c:size val="9"/>
              <c:spPr>
                <a:solidFill>
                  <a:srgbClr val="FFFF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49-8C29-5040-9158-0BE499FF9603}"/>
              </c:ext>
            </c:extLst>
          </c:dPt>
          <c:dPt>
            <c:idx val="74"/>
            <c:marker>
              <c:symbol val="circle"/>
              <c:size val="9"/>
              <c:spPr>
                <a:solidFill>
                  <a:srgbClr val="00B0F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4A-8C29-5040-9158-0BE499FF9603}"/>
              </c:ext>
            </c:extLst>
          </c:dPt>
          <c:dPt>
            <c:idx val="75"/>
            <c:marker>
              <c:symbol val="circle"/>
              <c:size val="9"/>
              <c:spPr>
                <a:solidFill>
                  <a:srgbClr val="92D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4B-8C29-5040-9158-0BE499FF9603}"/>
              </c:ext>
            </c:extLst>
          </c:dPt>
          <c:dPt>
            <c:idx val="76"/>
            <c:marker>
              <c:symbol val="circle"/>
              <c:size val="9"/>
              <c:spPr>
                <a:solidFill>
                  <a:srgbClr val="FFC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4C-8C29-5040-9158-0BE499FF9603}"/>
              </c:ext>
            </c:extLst>
          </c:dPt>
          <c:dPt>
            <c:idx val="77"/>
            <c:marker>
              <c:symbol val="circle"/>
              <c:size val="9"/>
              <c:spPr>
                <a:solidFill>
                  <a:srgbClr val="7030A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4D-8C29-5040-9158-0BE499FF9603}"/>
              </c:ext>
            </c:extLst>
          </c:dPt>
          <c:dPt>
            <c:idx val="78"/>
            <c:marker>
              <c:symbol val="circle"/>
              <c:size val="9"/>
              <c:spPr>
                <a:solidFill>
                  <a:schemeClr val="bg1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4E-8C29-5040-9158-0BE499FF9603}"/>
              </c:ext>
            </c:extLst>
          </c:dPt>
          <c:dPt>
            <c:idx val="79"/>
            <c:marker>
              <c:symbol val="circle"/>
              <c:size val="9"/>
              <c:spPr>
                <a:solidFill>
                  <a:srgbClr val="FF0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4F-8C29-5040-9158-0BE499FF9603}"/>
              </c:ext>
            </c:extLst>
          </c:dPt>
          <c:dPt>
            <c:idx val="80"/>
            <c:marker>
              <c:symbol val="circle"/>
              <c:size val="9"/>
              <c:spPr>
                <a:solidFill>
                  <a:srgbClr val="FFFF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50-8C29-5040-9158-0BE499FF9603}"/>
              </c:ext>
            </c:extLst>
          </c:dPt>
          <c:dPt>
            <c:idx val="81"/>
            <c:marker>
              <c:symbol val="circle"/>
              <c:size val="9"/>
              <c:spPr>
                <a:solidFill>
                  <a:srgbClr val="00B0F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51-8C29-5040-9158-0BE499FF9603}"/>
              </c:ext>
            </c:extLst>
          </c:dPt>
          <c:dPt>
            <c:idx val="82"/>
            <c:marker>
              <c:symbol val="circle"/>
              <c:size val="9"/>
              <c:spPr>
                <a:solidFill>
                  <a:srgbClr val="92D05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52-8C29-5040-9158-0BE499FF9603}"/>
              </c:ext>
            </c:extLst>
          </c:dPt>
          <c:dPt>
            <c:idx val="83"/>
            <c:marker>
              <c:symbol val="circle"/>
              <c:size val="9"/>
              <c:spPr>
                <a:solidFill>
                  <a:srgbClr val="FFC000"/>
                </a:solidFill>
                <a:ln w="9525">
                  <a:solidFill>
                    <a:schemeClr val="tx1"/>
                  </a:solidFill>
                </a:ln>
                <a:effectLst/>
              </c:spPr>
            </c:marker>
            <c:bubble3D val="0"/>
            <c:extLst>
              <c:ext xmlns:c16="http://schemas.microsoft.com/office/drawing/2014/chart" uri="{C3380CC4-5D6E-409C-BE32-E72D297353CC}">
                <c16:uniqueId val="{00000053-8C29-5040-9158-0BE499FF9603}"/>
              </c:ext>
            </c:extLst>
          </c:dPt>
          <c:xVal>
            <c:numRef>
              <c:f>'weighted_unifrac_pcoa_resul (2)'!$B$10:$B$93</c:f>
              <c:numCache>
                <c:formatCode>General</c:formatCode>
                <c:ptCount val="84"/>
                <c:pt idx="0">
                  <c:v>-0.36761671074680602</c:v>
                </c:pt>
                <c:pt idx="1">
                  <c:v>-0.34997054121145399</c:v>
                </c:pt>
                <c:pt idx="2">
                  <c:v>-0.37085982596414102</c:v>
                </c:pt>
                <c:pt idx="3">
                  <c:v>-0.33879005308924598</c:v>
                </c:pt>
                <c:pt idx="4">
                  <c:v>0.180087001978916</c:v>
                </c:pt>
                <c:pt idx="5">
                  <c:v>-0.31014823916039502</c:v>
                </c:pt>
                <c:pt idx="6">
                  <c:v>-0.30253244867789902</c:v>
                </c:pt>
                <c:pt idx="7">
                  <c:v>-0.38423633335082702</c:v>
                </c:pt>
                <c:pt idx="8">
                  <c:v>-0.35124434439811197</c:v>
                </c:pt>
                <c:pt idx="9">
                  <c:v>-0.38852700359061298</c:v>
                </c:pt>
                <c:pt idx="10">
                  <c:v>-0.36605588297885699</c:v>
                </c:pt>
                <c:pt idx="11">
                  <c:v>0.18377322186697001</c:v>
                </c:pt>
                <c:pt idx="12">
                  <c:v>-0.33098043087119</c:v>
                </c:pt>
                <c:pt idx="13">
                  <c:v>-0.34873754294088899</c:v>
                </c:pt>
                <c:pt idx="14">
                  <c:v>-0.32141898577639899</c:v>
                </c:pt>
                <c:pt idx="15">
                  <c:v>-0.335213555527067</c:v>
                </c:pt>
                <c:pt idx="16">
                  <c:v>-0.377655688928063</c:v>
                </c:pt>
                <c:pt idx="17">
                  <c:v>-0.32539237094953299</c:v>
                </c:pt>
                <c:pt idx="18">
                  <c:v>-0.21145637530780301</c:v>
                </c:pt>
                <c:pt idx="19">
                  <c:v>-0.34526329495396801</c:v>
                </c:pt>
                <c:pt idx="20">
                  <c:v>-0.15259388090242201</c:v>
                </c:pt>
                <c:pt idx="21">
                  <c:v>-0.30555853844619901</c:v>
                </c:pt>
                <c:pt idx="22">
                  <c:v>-0.23891618465435999</c:v>
                </c:pt>
                <c:pt idx="23">
                  <c:v>-0.33319430803488598</c:v>
                </c:pt>
                <c:pt idx="24">
                  <c:v>-0.244064514109404</c:v>
                </c:pt>
                <c:pt idx="25">
                  <c:v>0.36858747074591203</c:v>
                </c:pt>
                <c:pt idx="26">
                  <c:v>-0.27819232200303901</c:v>
                </c:pt>
                <c:pt idx="27">
                  <c:v>2.7666752454514699E-2</c:v>
                </c:pt>
                <c:pt idx="28">
                  <c:v>-0.37669630705117402</c:v>
                </c:pt>
                <c:pt idx="29">
                  <c:v>-0.353952492406925</c:v>
                </c:pt>
                <c:pt idx="30">
                  <c:v>-0.364916077380324</c:v>
                </c:pt>
                <c:pt idx="31">
                  <c:v>-0.35332910031457099</c:v>
                </c:pt>
                <c:pt idx="32">
                  <c:v>0.111673357475033</c:v>
                </c:pt>
                <c:pt idx="33">
                  <c:v>-0.28661543188759397</c:v>
                </c:pt>
                <c:pt idx="34">
                  <c:v>-0.246836324879145</c:v>
                </c:pt>
                <c:pt idx="35">
                  <c:v>-0.3312973631751</c:v>
                </c:pt>
                <c:pt idx="36">
                  <c:v>-0.30492305328568198</c:v>
                </c:pt>
                <c:pt idx="37">
                  <c:v>-0.36675415920231302</c:v>
                </c:pt>
                <c:pt idx="38">
                  <c:v>-0.27009006518636702</c:v>
                </c:pt>
                <c:pt idx="39">
                  <c:v>-0.121692107935275</c:v>
                </c:pt>
                <c:pt idx="40">
                  <c:v>-0.27752867637038697</c:v>
                </c:pt>
                <c:pt idx="41">
                  <c:v>-0.16210290946611999</c:v>
                </c:pt>
                <c:pt idx="42">
                  <c:v>0.10578714922424499</c:v>
                </c:pt>
                <c:pt idx="43">
                  <c:v>-7.6664503638705001E-2</c:v>
                </c:pt>
                <c:pt idx="44">
                  <c:v>0.14635568906475899</c:v>
                </c:pt>
                <c:pt idx="45">
                  <c:v>-5.00844147401927E-2</c:v>
                </c:pt>
                <c:pt idx="46">
                  <c:v>0.42119393051176401</c:v>
                </c:pt>
                <c:pt idx="47">
                  <c:v>0.49454141319849698</c:v>
                </c:pt>
                <c:pt idx="48">
                  <c:v>0.43314375482663497</c:v>
                </c:pt>
                <c:pt idx="49">
                  <c:v>0.20500767653563901</c:v>
                </c:pt>
                <c:pt idx="50">
                  <c:v>0.123050483724312</c:v>
                </c:pt>
                <c:pt idx="51">
                  <c:v>0.25373304590604701</c:v>
                </c:pt>
                <c:pt idx="52">
                  <c:v>0.16403590023210499</c:v>
                </c:pt>
                <c:pt idx="53">
                  <c:v>0.49130248388812198</c:v>
                </c:pt>
                <c:pt idx="54">
                  <c:v>0.50504363812068798</c:v>
                </c:pt>
                <c:pt idx="55">
                  <c:v>0.33983736750189902</c:v>
                </c:pt>
                <c:pt idx="56">
                  <c:v>0.191213860533613</c:v>
                </c:pt>
                <c:pt idx="57">
                  <c:v>0.19956181207589799</c:v>
                </c:pt>
                <c:pt idx="58">
                  <c:v>0.16404258262472801</c:v>
                </c:pt>
                <c:pt idx="59">
                  <c:v>0.229692702058303</c:v>
                </c:pt>
                <c:pt idx="60">
                  <c:v>0.36544557643292302</c:v>
                </c:pt>
                <c:pt idx="61">
                  <c:v>0.48868376264906099</c:v>
                </c:pt>
                <c:pt idx="62">
                  <c:v>0.40347569883988499</c:v>
                </c:pt>
                <c:pt idx="63">
                  <c:v>-3.9708246942885002E-2</c:v>
                </c:pt>
                <c:pt idx="64">
                  <c:v>9.5265787160247806E-2</c:v>
                </c:pt>
                <c:pt idx="65">
                  <c:v>1.8090527640846201E-2</c:v>
                </c:pt>
                <c:pt idx="66">
                  <c:v>0.11524666924711301</c:v>
                </c:pt>
                <c:pt idx="67">
                  <c:v>0.47671234978806198</c:v>
                </c:pt>
                <c:pt idx="68">
                  <c:v>0.52788888061374295</c:v>
                </c:pt>
                <c:pt idx="69">
                  <c:v>0.38492506064720899</c:v>
                </c:pt>
                <c:pt idx="70">
                  <c:v>7.4079356872134794E-2</c:v>
                </c:pt>
                <c:pt idx="71">
                  <c:v>3.80755668507885E-2</c:v>
                </c:pt>
                <c:pt idx="72">
                  <c:v>0.13561672031754701</c:v>
                </c:pt>
                <c:pt idx="73">
                  <c:v>0.125506252025752</c:v>
                </c:pt>
                <c:pt idx="74">
                  <c:v>0.46855602529499502</c:v>
                </c:pt>
                <c:pt idx="75">
                  <c:v>0.51922578801084895</c:v>
                </c:pt>
                <c:pt idx="76">
                  <c:v>0.418547903848009</c:v>
                </c:pt>
                <c:pt idx="77">
                  <c:v>0.19082356124357799</c:v>
                </c:pt>
                <c:pt idx="78">
                  <c:v>4.59255926830969E-2</c:v>
                </c:pt>
                <c:pt idx="79">
                  <c:v>8.3846128877202997E-2</c:v>
                </c:pt>
                <c:pt idx="80">
                  <c:v>5.3632540275684697E-2</c:v>
                </c:pt>
                <c:pt idx="81">
                  <c:v>0.43497601301572503</c:v>
                </c:pt>
                <c:pt idx="82">
                  <c:v>0.50801750115579503</c:v>
                </c:pt>
                <c:pt idx="83">
                  <c:v>0.34991605239748103</c:v>
                </c:pt>
              </c:numCache>
            </c:numRef>
          </c:xVal>
          <c:yVal>
            <c:numRef>
              <c:f>'weighted_unifrac_pcoa_resul (2)'!$C$10:$C$93</c:f>
              <c:numCache>
                <c:formatCode>General</c:formatCode>
                <c:ptCount val="84"/>
                <c:pt idx="0">
                  <c:v>-1.2098324608078401E-2</c:v>
                </c:pt>
                <c:pt idx="1">
                  <c:v>7.4609808255696802E-3</c:v>
                </c:pt>
                <c:pt idx="2">
                  <c:v>6.2476087915041598E-2</c:v>
                </c:pt>
                <c:pt idx="3">
                  <c:v>-4.6577168448384502E-3</c:v>
                </c:pt>
                <c:pt idx="4">
                  <c:v>-0.34899231477281001</c:v>
                </c:pt>
                <c:pt idx="5">
                  <c:v>0.13057928106611799</c:v>
                </c:pt>
                <c:pt idx="6">
                  <c:v>-4.14175994532123E-2</c:v>
                </c:pt>
                <c:pt idx="7">
                  <c:v>-0.16066920201754201</c:v>
                </c:pt>
                <c:pt idx="8">
                  <c:v>1.8831409365838499E-2</c:v>
                </c:pt>
                <c:pt idx="9">
                  <c:v>9.5857393089757107E-3</c:v>
                </c:pt>
                <c:pt idx="10">
                  <c:v>5.7099964285181201E-2</c:v>
                </c:pt>
                <c:pt idx="11">
                  <c:v>-0.37761776954999798</c:v>
                </c:pt>
                <c:pt idx="12">
                  <c:v>0.11539949274637901</c:v>
                </c:pt>
                <c:pt idx="13">
                  <c:v>-3.05664006122001E-2</c:v>
                </c:pt>
                <c:pt idx="14">
                  <c:v>-0.191950601539053</c:v>
                </c:pt>
                <c:pt idx="15">
                  <c:v>1.0450142595783101E-2</c:v>
                </c:pt>
                <c:pt idx="16">
                  <c:v>-0.11605798171005401</c:v>
                </c:pt>
                <c:pt idx="17">
                  <c:v>-0.14083988591160601</c:v>
                </c:pt>
                <c:pt idx="18">
                  <c:v>3.4749826271839597E-2</c:v>
                </c:pt>
                <c:pt idx="19">
                  <c:v>1.52593885677881E-2</c:v>
                </c:pt>
                <c:pt idx="20">
                  <c:v>-0.223633115974786</c:v>
                </c:pt>
                <c:pt idx="21">
                  <c:v>-0.123802705213263</c:v>
                </c:pt>
                <c:pt idx="22">
                  <c:v>-0.15376722322242101</c:v>
                </c:pt>
                <c:pt idx="23">
                  <c:v>-0.24699649347876901</c:v>
                </c:pt>
                <c:pt idx="24">
                  <c:v>-0.120103697586723</c:v>
                </c:pt>
                <c:pt idx="25">
                  <c:v>-0.172651657251569</c:v>
                </c:pt>
                <c:pt idx="26">
                  <c:v>8.5947767085075094E-2</c:v>
                </c:pt>
                <c:pt idx="27">
                  <c:v>-8.3727281771243306E-2</c:v>
                </c:pt>
                <c:pt idx="28">
                  <c:v>-0.13688162278745999</c:v>
                </c:pt>
                <c:pt idx="29">
                  <c:v>-8.9504827425910705E-2</c:v>
                </c:pt>
                <c:pt idx="30">
                  <c:v>-7.2469181389918202E-2</c:v>
                </c:pt>
                <c:pt idx="31">
                  <c:v>-0.17166554513830201</c:v>
                </c:pt>
                <c:pt idx="32">
                  <c:v>-9.6435277685605905E-2</c:v>
                </c:pt>
                <c:pt idx="33">
                  <c:v>-3.2228504299346303E-2</c:v>
                </c:pt>
                <c:pt idx="34">
                  <c:v>-0.19363335537185999</c:v>
                </c:pt>
                <c:pt idx="35">
                  <c:v>-0.15291340315724899</c:v>
                </c:pt>
                <c:pt idx="36">
                  <c:v>-0.192248654931647</c:v>
                </c:pt>
                <c:pt idx="37">
                  <c:v>-0.135640666502538</c:v>
                </c:pt>
                <c:pt idx="38">
                  <c:v>-0.132700425713079</c:v>
                </c:pt>
                <c:pt idx="39">
                  <c:v>-1.54585593066739E-2</c:v>
                </c:pt>
                <c:pt idx="40">
                  <c:v>6.3684842694683302E-2</c:v>
                </c:pt>
                <c:pt idx="41">
                  <c:v>-4.2321740667424099E-2</c:v>
                </c:pt>
                <c:pt idx="42">
                  <c:v>0.243725899095349</c:v>
                </c:pt>
                <c:pt idx="43">
                  <c:v>0.22201704987055301</c:v>
                </c:pt>
                <c:pt idx="44">
                  <c:v>0.19686891769500101</c:v>
                </c:pt>
                <c:pt idx="45">
                  <c:v>0.23358430191054</c:v>
                </c:pt>
                <c:pt idx="46">
                  <c:v>-0.17586420448302001</c:v>
                </c:pt>
                <c:pt idx="47">
                  <c:v>-0.18382905852155401</c:v>
                </c:pt>
                <c:pt idx="48">
                  <c:v>-8.7149598697889505E-2</c:v>
                </c:pt>
                <c:pt idx="49">
                  <c:v>0.26554296094438501</c:v>
                </c:pt>
                <c:pt idx="50">
                  <c:v>0.27349487716779902</c:v>
                </c:pt>
                <c:pt idx="51">
                  <c:v>0.24147469885008599</c:v>
                </c:pt>
                <c:pt idx="52">
                  <c:v>0.266720028096816</c:v>
                </c:pt>
                <c:pt idx="53">
                  <c:v>-0.22391654158533</c:v>
                </c:pt>
                <c:pt idx="54">
                  <c:v>-0.18564535840820001</c:v>
                </c:pt>
                <c:pt idx="55">
                  <c:v>0.14592774996119201</c:v>
                </c:pt>
                <c:pt idx="56">
                  <c:v>0.21584199471603299</c:v>
                </c:pt>
                <c:pt idx="57">
                  <c:v>0.223100644745685</c:v>
                </c:pt>
                <c:pt idx="58">
                  <c:v>0.23469941014767001</c:v>
                </c:pt>
                <c:pt idx="59">
                  <c:v>0.24525017784336001</c:v>
                </c:pt>
                <c:pt idx="60">
                  <c:v>-0.15730796670358099</c:v>
                </c:pt>
                <c:pt idx="61">
                  <c:v>-0.16625772646711501</c:v>
                </c:pt>
                <c:pt idx="62">
                  <c:v>-1.1326668492819301E-2</c:v>
                </c:pt>
                <c:pt idx="63">
                  <c:v>0.25899337860629301</c:v>
                </c:pt>
                <c:pt idx="64">
                  <c:v>0.24305003342256501</c:v>
                </c:pt>
                <c:pt idx="65">
                  <c:v>0.26639097371755699</c:v>
                </c:pt>
                <c:pt idx="66">
                  <c:v>0.22263506049111201</c:v>
                </c:pt>
                <c:pt idx="67">
                  <c:v>-0.212179573682898</c:v>
                </c:pt>
                <c:pt idx="68">
                  <c:v>-0.198102324668957</c:v>
                </c:pt>
                <c:pt idx="69">
                  <c:v>5.21061980508703E-2</c:v>
                </c:pt>
                <c:pt idx="70">
                  <c:v>0.204205429068579</c:v>
                </c:pt>
                <c:pt idx="71">
                  <c:v>0.214036646936311</c:v>
                </c:pt>
                <c:pt idx="72">
                  <c:v>0.17651957083766201</c:v>
                </c:pt>
                <c:pt idx="73">
                  <c:v>0.24523051660679501</c:v>
                </c:pt>
                <c:pt idx="74">
                  <c:v>-0.20126508277576599</c:v>
                </c:pt>
                <c:pt idx="75">
                  <c:v>-0.1947460763254</c:v>
                </c:pt>
                <c:pt idx="76">
                  <c:v>-0.104838209603411</c:v>
                </c:pt>
                <c:pt idx="77">
                  <c:v>0.261813479298523</c:v>
                </c:pt>
                <c:pt idx="78">
                  <c:v>0.24848408278792999</c:v>
                </c:pt>
                <c:pt idx="79">
                  <c:v>0.26590864695905497</c:v>
                </c:pt>
                <c:pt idx="80">
                  <c:v>0.22198413971559999</c:v>
                </c:pt>
                <c:pt idx="81">
                  <c:v>-0.21611511219385501</c:v>
                </c:pt>
                <c:pt idx="82">
                  <c:v>-0.18617847385972799</c:v>
                </c:pt>
                <c:pt idx="83">
                  <c:v>1.72419220931165E-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54-8C29-5040-9158-0BE499FF960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860506431"/>
        <c:axId val="860508111"/>
      </c:scatterChart>
      <c:valAx>
        <c:axId val="860506431"/>
        <c:scaling>
          <c:orientation val="minMax"/>
        </c:scaling>
        <c:delete val="0"/>
        <c:axPos val="b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60508111"/>
        <c:crosses val="autoZero"/>
        <c:crossBetween val="midCat"/>
      </c:valAx>
      <c:valAx>
        <c:axId val="860508111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12700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860506431"/>
        <c:crosses val="autoZero"/>
        <c:crossBetween val="midCat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Alpha_div!$L$1</c:f>
              <c:strCache>
                <c:ptCount val="1"/>
                <c:pt idx="0">
                  <c:v>Shanno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Pt>
            <c:idx val="0"/>
            <c:invertIfNegative val="0"/>
            <c:bubble3D val="0"/>
            <c:spPr>
              <a:solidFill>
                <a:srgbClr val="00B0F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F167-AF4A-A3E7-913F15B634C5}"/>
              </c:ext>
            </c:extLst>
          </c:dPt>
          <c:dPt>
            <c:idx val="1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F167-AF4A-A3E7-913F15B634C5}"/>
              </c:ext>
            </c:extLst>
          </c:dPt>
          <c:dPt>
            <c:idx val="2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F167-AF4A-A3E7-913F15B634C5}"/>
              </c:ext>
            </c:extLst>
          </c:dPt>
          <c:dPt>
            <c:idx val="3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F167-AF4A-A3E7-913F15B634C5}"/>
              </c:ext>
            </c:extLst>
          </c:dPt>
          <c:dPt>
            <c:idx val="4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F167-AF4A-A3E7-913F15B634C5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F167-AF4A-A3E7-913F15B634C5}"/>
              </c:ext>
            </c:extLst>
          </c:dPt>
          <c:dPt>
            <c:idx val="6"/>
            <c:invertIfNegative val="0"/>
            <c:bubble3D val="0"/>
            <c:spPr>
              <a:solidFill>
                <a:srgbClr val="FFFF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E-F167-AF4A-A3E7-913F15B634C5}"/>
              </c:ext>
            </c:extLst>
          </c:dPt>
          <c:dPt>
            <c:idx val="7"/>
            <c:invertIfNegative val="0"/>
            <c:bubble3D val="0"/>
            <c:spPr>
              <a:solidFill>
                <a:srgbClr val="00B0F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F167-AF4A-A3E7-913F15B634C5}"/>
              </c:ext>
            </c:extLst>
          </c:dPt>
          <c:dPt>
            <c:idx val="8"/>
            <c:invertIfNegative val="0"/>
            <c:bubble3D val="0"/>
            <c:spPr>
              <a:solidFill>
                <a:srgbClr val="92D05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4-F167-AF4A-A3E7-913F15B634C5}"/>
              </c:ext>
            </c:extLst>
          </c:dPt>
          <c:dPt>
            <c:idx val="9"/>
            <c:invertIfNegative val="0"/>
            <c:bubble3D val="0"/>
            <c:spPr>
              <a:solidFill>
                <a:srgbClr val="FFC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F167-AF4A-A3E7-913F15B634C5}"/>
              </c:ext>
            </c:extLst>
          </c:dPt>
          <c:dPt>
            <c:idx val="10"/>
            <c:invertIfNegative val="0"/>
            <c:bubble3D val="0"/>
            <c:spPr>
              <a:solidFill>
                <a:srgbClr val="FF00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8-F167-AF4A-A3E7-913F15B634C5}"/>
              </c:ext>
            </c:extLst>
          </c:dPt>
          <c:dPt>
            <c:idx val="11"/>
            <c:invertIfNegative val="0"/>
            <c:bubble3D val="0"/>
            <c:spPr>
              <a:solidFill>
                <a:srgbClr val="7030A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A-F167-AF4A-A3E7-913F15B634C5}"/>
              </c:ext>
            </c:extLst>
          </c:dPt>
          <c:dPt>
            <c:idx val="12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C-F167-AF4A-A3E7-913F15B634C5}"/>
              </c:ext>
            </c:extLst>
          </c:dPt>
          <c:dPt>
            <c:idx val="13"/>
            <c:invertIfNegative val="0"/>
            <c:bubble3D val="0"/>
            <c:spPr>
              <a:solidFill>
                <a:srgbClr val="FFFF00"/>
              </a:solid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F167-AF4A-A3E7-913F15B634C5}"/>
              </c:ext>
            </c:extLst>
          </c:dPt>
          <c:errBars>
            <c:errBarType val="plus"/>
            <c:errValType val="cust"/>
            <c:noEndCap val="0"/>
            <c:plus>
              <c:numRef>
                <c:f>Alpha_div!$L$18:$L$31</c:f>
                <c:numCache>
                  <c:formatCode>General</c:formatCode>
                  <c:ptCount val="14"/>
                  <c:pt idx="0">
                    <c:v>0.87193385582245164</c:v>
                  </c:pt>
                  <c:pt idx="1">
                    <c:v>0.1856719244050678</c:v>
                  </c:pt>
                  <c:pt idx="2">
                    <c:v>0.25518594063147232</c:v>
                  </c:pt>
                  <c:pt idx="3">
                    <c:v>0.2537894753608872</c:v>
                  </c:pt>
                  <c:pt idx="4">
                    <c:v>0.15189644626781715</c:v>
                  </c:pt>
                  <c:pt idx="5">
                    <c:v>0.25263524759328404</c:v>
                  </c:pt>
                  <c:pt idx="6">
                    <c:v>0.24923147081721528</c:v>
                  </c:pt>
                  <c:pt idx="7">
                    <c:v>0.15063614077988249</c:v>
                  </c:pt>
                  <c:pt idx="8">
                    <c:v>0.12444422334553046</c:v>
                  </c:pt>
                  <c:pt idx="9">
                    <c:v>0.21049623193600031</c:v>
                  </c:pt>
                  <c:pt idx="10">
                    <c:v>0.11487749077209872</c:v>
                  </c:pt>
                  <c:pt idx="11">
                    <c:v>0.12596607979740343</c:v>
                  </c:pt>
                  <c:pt idx="12">
                    <c:v>0.11025213583530082</c:v>
                  </c:pt>
                  <c:pt idx="13">
                    <c:v>0.15989203058683049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multiLvlStrRef>
              <c:f>Alpha_div!$J$2:$K$15</c:f>
              <c:multiLvlStrCache>
                <c:ptCount val="14"/>
                <c:lvl>
                  <c:pt idx="0">
                    <c:v>St</c:v>
                  </c:pt>
                  <c:pt idx="1">
                    <c:v>Je</c:v>
                  </c:pt>
                  <c:pt idx="2">
                    <c:v>IL</c:v>
                  </c:pt>
                  <c:pt idx="3">
                    <c:v>Ce</c:v>
                  </c:pt>
                  <c:pt idx="4">
                    <c:v>PC</c:v>
                  </c:pt>
                  <c:pt idx="5">
                    <c:v>DC</c:v>
                  </c:pt>
                  <c:pt idx="6">
                    <c:v>Re</c:v>
                  </c:pt>
                  <c:pt idx="7">
                    <c:v>St</c:v>
                  </c:pt>
                  <c:pt idx="8">
                    <c:v>Je</c:v>
                  </c:pt>
                  <c:pt idx="9">
                    <c:v>IL</c:v>
                  </c:pt>
                  <c:pt idx="10">
                    <c:v>Ce</c:v>
                  </c:pt>
                  <c:pt idx="11">
                    <c:v>PC</c:v>
                  </c:pt>
                  <c:pt idx="12">
                    <c:v>DC</c:v>
                  </c:pt>
                  <c:pt idx="13">
                    <c:v>Re</c:v>
                  </c:pt>
                </c:lvl>
                <c:lvl>
                  <c:pt idx="0">
                    <c:v>Mucosa</c:v>
                  </c:pt>
                  <c:pt idx="7">
                    <c:v>Digesta</c:v>
                  </c:pt>
                </c:lvl>
              </c:multiLvlStrCache>
            </c:multiLvlStrRef>
          </c:cat>
          <c:val>
            <c:numRef>
              <c:f>Alpha_div!$L$2:$L$15</c:f>
              <c:numCache>
                <c:formatCode>General</c:formatCode>
                <c:ptCount val="14"/>
                <c:pt idx="0">
                  <c:v>4.9516515712044633</c:v>
                </c:pt>
                <c:pt idx="1">
                  <c:v>7.4439554075853094</c:v>
                </c:pt>
                <c:pt idx="2">
                  <c:v>6.4009777756421453</c:v>
                </c:pt>
                <c:pt idx="3">
                  <c:v>6.383486549179632</c:v>
                </c:pt>
                <c:pt idx="4">
                  <c:v>6.1250569460292716</c:v>
                </c:pt>
                <c:pt idx="5">
                  <c:v>6.8083306007606028</c:v>
                </c:pt>
                <c:pt idx="6">
                  <c:v>6.6208394373565502</c:v>
                </c:pt>
                <c:pt idx="7">
                  <c:v>4.9000034974170177</c:v>
                </c:pt>
                <c:pt idx="8">
                  <c:v>3.8963661341805</c:v>
                </c:pt>
                <c:pt idx="9">
                  <c:v>3.6851154518287235</c:v>
                </c:pt>
                <c:pt idx="10">
                  <c:v>6.5599636616679495</c:v>
                </c:pt>
                <c:pt idx="11">
                  <c:v>6.8468585978063112</c:v>
                </c:pt>
                <c:pt idx="12">
                  <c:v>7.0576057477914418</c:v>
                </c:pt>
                <c:pt idx="13">
                  <c:v>6.771804824859970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167-AF4A-A3E7-913F15B634C5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11328176"/>
        <c:axId val="411853152"/>
      </c:barChart>
      <c:catAx>
        <c:axId val="411328176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spPr>
          <a:noFill/>
          <a:ln w="1587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1853152"/>
        <c:crosses val="autoZero"/>
        <c:auto val="1"/>
        <c:lblAlgn val="ctr"/>
        <c:lblOffset val="100"/>
        <c:noMultiLvlLbl val="0"/>
      </c:catAx>
      <c:valAx>
        <c:axId val="41185315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out"/>
        <c:minorTickMark val="none"/>
        <c:tickLblPos val="nextTo"/>
        <c:spPr>
          <a:noFill/>
          <a:ln w="15875"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900" b="0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41132817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70CF5-6CB3-6D41-9AE1-8C660F01E003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34598-2D5F-5743-9EA5-F7D56A4656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541335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70CF5-6CB3-6D41-9AE1-8C660F01E003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34598-2D5F-5743-9EA5-F7D56A4656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132719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70CF5-6CB3-6D41-9AE1-8C660F01E003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34598-2D5F-5743-9EA5-F7D56A4656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2622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70CF5-6CB3-6D41-9AE1-8C660F01E003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34598-2D5F-5743-9EA5-F7D56A4656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80139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70CF5-6CB3-6D41-9AE1-8C660F01E003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34598-2D5F-5743-9EA5-F7D56A4656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592512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70CF5-6CB3-6D41-9AE1-8C660F01E003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34598-2D5F-5743-9EA5-F7D56A4656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52114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70CF5-6CB3-6D41-9AE1-8C660F01E003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34598-2D5F-5743-9EA5-F7D56A4656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74724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70CF5-6CB3-6D41-9AE1-8C660F01E003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34598-2D5F-5743-9EA5-F7D56A4656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417675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70CF5-6CB3-6D41-9AE1-8C660F01E003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34598-2D5F-5743-9EA5-F7D56A4656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054903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70CF5-6CB3-6D41-9AE1-8C660F01E003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34598-2D5F-5743-9EA5-F7D56A4656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50500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2070CF5-6CB3-6D41-9AE1-8C660F01E003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634598-2D5F-5743-9EA5-F7D56A4656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5106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
第 </a:t>
            </a:r>
            <a:r>
              <a:rPr lang="en-US" altLang="ja-JP"/>
              <a:t>2 </a:t>
            </a:r>
            <a:r>
              <a:rPr lang="ja-JP" altLang="en-US"/>
              <a:t>レベル
第 </a:t>
            </a:r>
            <a:r>
              <a:rPr lang="en-US" altLang="ja-JP"/>
              <a:t>3 </a:t>
            </a:r>
            <a:r>
              <a:rPr lang="ja-JP" altLang="en-US"/>
              <a:t>レベル
第 </a:t>
            </a:r>
            <a:r>
              <a:rPr lang="en-US" altLang="ja-JP"/>
              <a:t>4 </a:t>
            </a:r>
            <a:r>
              <a:rPr lang="ja-JP" altLang="en-US"/>
              <a:t>レベル
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2070CF5-6CB3-6D41-9AE1-8C660F01E003}" type="datetimeFigureOut">
              <a:rPr kumimoji="1" lang="ja-JP" altLang="en-US" smtClean="0"/>
              <a:t>2025/1/24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634598-2D5F-5743-9EA5-F7D56A4656B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563749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6" name="グラフ 15">
            <a:extLst>
              <a:ext uri="{FF2B5EF4-FFF2-40B4-BE49-F238E27FC236}">
                <a16:creationId xmlns:a16="http://schemas.microsoft.com/office/drawing/2014/main" id="{17177D5C-F92A-C043-8B3F-E09BBC763B6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35611868"/>
              </p:ext>
            </p:extLst>
          </p:nvPr>
        </p:nvGraphicFramePr>
        <p:xfrm>
          <a:off x="3442770" y="320496"/>
          <a:ext cx="3415230" cy="199624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12A05C5C-5D34-6245-9031-D56D4CE96A7D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3511269"/>
              </p:ext>
            </p:extLst>
          </p:nvPr>
        </p:nvGraphicFramePr>
        <p:xfrm>
          <a:off x="285177" y="2504058"/>
          <a:ext cx="6287646" cy="456390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F865317D-33FF-934F-9070-CD7250C6D2E5}"/>
              </a:ext>
            </a:extLst>
          </p:cNvPr>
          <p:cNvSpPr txBox="1"/>
          <p:nvPr/>
        </p:nvSpPr>
        <p:spPr>
          <a:xfrm>
            <a:off x="76211" y="7322441"/>
            <a:ext cx="6673724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b="1">
                <a:latin typeface="Times New Roman" panose="02020603050405020304" pitchFamily="18" charset="0"/>
                <a:cs typeface="Times New Roman" panose="02020603050405020304" pitchFamily="18" charset="0"/>
              </a:rPr>
              <a:t>Figure S1. </a:t>
            </a:r>
            <a:r>
              <a:rPr kumimoji="1" lang="en-US" altLang="ja-JP" sz="1600" dirty="0">
                <a:latin typeface="Symbol" pitchFamily="2" charset="2"/>
                <a:cs typeface="Times New Roman" panose="02020603050405020304" pitchFamily="18" charset="0"/>
              </a:rPr>
              <a:t>a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kumimoji="1" lang="en-US" altLang="ja-JP" sz="1600" dirty="0">
                <a:latin typeface="Symbol" pitchFamily="2" charset="2"/>
                <a:cs typeface="Times New Roman" panose="02020603050405020304" pitchFamily="18" charset="0"/>
              </a:rPr>
              <a:t>b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diversities of gut microbiotas in porcine mucosa and </a:t>
            </a:r>
            <a:r>
              <a:rPr kumimoji="1" lang="en-US" altLang="ja-JP" sz="16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gestas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FEBE694-44C4-2D45-AF1C-056CF852B1DD}"/>
              </a:ext>
            </a:extLst>
          </p:cNvPr>
          <p:cNvSpPr txBox="1"/>
          <p:nvPr/>
        </p:nvSpPr>
        <p:spPr>
          <a:xfrm>
            <a:off x="180694" y="7907216"/>
            <a:ext cx="646475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lue symbols, stomachs (St);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green symbols,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jejuna (Je);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ange symbols,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ilea (IL);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 symbols,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eca (Ce);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urple symbols, </a:t>
            </a:r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ximal colons (PC); white symbols, distal colons (DC); and yellow symbols, recta (Re).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nel A, Shannon indices. Panel B, Chao 1 indices. Panel C, weighted principal-coordinate analysis (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CoA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lots. Circles, </a:t>
            </a:r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digestas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; and triangles, mucosae. </a:t>
            </a:r>
            <a:r>
              <a:rPr lang="en-US" altLang="ja-JP" sz="1200">
                <a:latin typeface="Times New Roman" panose="02020603050405020304" pitchFamily="18" charset="0"/>
                <a:cs typeface="Times New Roman" panose="02020603050405020304" pitchFamily="18" charset="0"/>
              </a:rPr>
              <a:t>In panels </a:t>
            </a: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&amp;B, bars represent the means ± the SE. Different letters indicate significant differences between the inter- and intra-regions of the alimentary tracts.</a:t>
            </a:r>
            <a:endParaRPr kumimoji="1" lang="ja-JP" alt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106DC448-3025-B747-B3F0-7D9065455B85}"/>
              </a:ext>
            </a:extLst>
          </p:cNvPr>
          <p:cNvSpPr txBox="1"/>
          <p:nvPr/>
        </p:nvSpPr>
        <p:spPr>
          <a:xfrm>
            <a:off x="8092" y="95076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B16DDAA-4B45-9348-806A-4AFC5D2615BF}"/>
              </a:ext>
            </a:extLst>
          </p:cNvPr>
          <p:cNvSpPr txBox="1"/>
          <p:nvPr/>
        </p:nvSpPr>
        <p:spPr>
          <a:xfrm>
            <a:off x="3445183" y="93920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2B45EA66-7F79-FC42-9300-5D259D9A4AD6}"/>
              </a:ext>
            </a:extLst>
          </p:cNvPr>
          <p:cNvSpPr txBox="1"/>
          <p:nvPr/>
        </p:nvSpPr>
        <p:spPr>
          <a:xfrm>
            <a:off x="456537" y="2582079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9D7DE28A-F5B8-EA40-A724-184D91CC7568}"/>
              </a:ext>
            </a:extLst>
          </p:cNvPr>
          <p:cNvSpPr txBox="1"/>
          <p:nvPr/>
        </p:nvSpPr>
        <p:spPr>
          <a:xfrm>
            <a:off x="5445941" y="444449"/>
            <a:ext cx="2535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0A67748-3598-D24E-8F61-2BA776B30701}"/>
              </a:ext>
            </a:extLst>
          </p:cNvPr>
          <p:cNvSpPr txBox="1"/>
          <p:nvPr/>
        </p:nvSpPr>
        <p:spPr>
          <a:xfrm>
            <a:off x="5616198" y="968369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EE22E21B-A000-E942-9107-88574E35DB98}"/>
              </a:ext>
            </a:extLst>
          </p:cNvPr>
          <p:cNvSpPr txBox="1"/>
          <p:nvPr/>
        </p:nvSpPr>
        <p:spPr>
          <a:xfrm>
            <a:off x="4354195" y="533048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A543C10F-9F21-F449-AF21-A17F1279CE7E}"/>
              </a:ext>
            </a:extLst>
          </p:cNvPr>
          <p:cNvSpPr txBox="1"/>
          <p:nvPr/>
        </p:nvSpPr>
        <p:spPr>
          <a:xfrm>
            <a:off x="3904377" y="556541"/>
            <a:ext cx="3994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c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14" name="グラフ 13">
            <a:extLst>
              <a:ext uri="{FF2B5EF4-FFF2-40B4-BE49-F238E27FC236}">
                <a16:creationId xmlns:a16="http://schemas.microsoft.com/office/drawing/2014/main" id="{896BBA1C-2997-8C4C-A105-FDBC93F8317E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072444422"/>
              </p:ext>
            </p:extLst>
          </p:nvPr>
        </p:nvGraphicFramePr>
        <p:xfrm>
          <a:off x="50456" y="320496"/>
          <a:ext cx="3378544" cy="197142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25640D5D-D6E6-EE4B-86E3-9DAB367ACF66}"/>
              </a:ext>
            </a:extLst>
          </p:cNvPr>
          <p:cNvSpPr txBox="1"/>
          <p:nvPr/>
        </p:nvSpPr>
        <p:spPr>
          <a:xfrm>
            <a:off x="5865377" y="386457"/>
            <a:ext cx="2535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E21FBBBE-FB9B-D344-987E-E4B6CBCF0CBE}"/>
              </a:ext>
            </a:extLst>
          </p:cNvPr>
          <p:cNvSpPr txBox="1"/>
          <p:nvPr/>
        </p:nvSpPr>
        <p:spPr>
          <a:xfrm>
            <a:off x="6488461" y="313629"/>
            <a:ext cx="25359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2CC8110E-59A9-AA40-AAEF-2EDAEA96DC63}"/>
              </a:ext>
            </a:extLst>
          </p:cNvPr>
          <p:cNvSpPr txBox="1"/>
          <p:nvPr/>
        </p:nvSpPr>
        <p:spPr>
          <a:xfrm>
            <a:off x="4984023" y="491240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7DCA301F-9D2B-9542-8BEB-E79A1A2B4A38}"/>
              </a:ext>
            </a:extLst>
          </p:cNvPr>
          <p:cNvSpPr txBox="1"/>
          <p:nvPr/>
        </p:nvSpPr>
        <p:spPr>
          <a:xfrm>
            <a:off x="5201159" y="530352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0FFA1AA3-D67A-7146-B8DE-A577724955AC}"/>
              </a:ext>
            </a:extLst>
          </p:cNvPr>
          <p:cNvSpPr txBox="1"/>
          <p:nvPr/>
        </p:nvSpPr>
        <p:spPr>
          <a:xfrm>
            <a:off x="4113421" y="660389"/>
            <a:ext cx="3994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c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B9D2B3C2-DA01-FA4C-AAEE-F8545DE99FD2}"/>
              </a:ext>
            </a:extLst>
          </p:cNvPr>
          <p:cNvSpPr txBox="1"/>
          <p:nvPr/>
        </p:nvSpPr>
        <p:spPr>
          <a:xfrm>
            <a:off x="4743249" y="570029"/>
            <a:ext cx="39946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bc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F0ED2C07-893C-194A-ACF1-5563D51CB7C4}"/>
              </a:ext>
            </a:extLst>
          </p:cNvPr>
          <p:cNvSpPr txBox="1"/>
          <p:nvPr/>
        </p:nvSpPr>
        <p:spPr>
          <a:xfrm>
            <a:off x="6271564" y="1218079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F4ADA41A-357B-9140-A479-0341B1E92613}"/>
              </a:ext>
            </a:extLst>
          </p:cNvPr>
          <p:cNvSpPr txBox="1"/>
          <p:nvPr/>
        </p:nvSpPr>
        <p:spPr>
          <a:xfrm>
            <a:off x="6027542" y="991297"/>
            <a:ext cx="33054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C99815B-2F89-AF40-96D6-95A077BC3048}"/>
              </a:ext>
            </a:extLst>
          </p:cNvPr>
          <p:cNvSpPr txBox="1"/>
          <p:nvPr/>
        </p:nvSpPr>
        <p:spPr>
          <a:xfrm>
            <a:off x="3725541" y="748363"/>
            <a:ext cx="330539" cy="3304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940"/>
              </a:lnSpc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</a:p>
          <a:p>
            <a:pPr algn="ctr">
              <a:lnSpc>
                <a:spcPts val="940"/>
              </a:lnSpc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79EE7312-039D-4F48-9AB1-DDADE4395E9D}"/>
              </a:ext>
            </a:extLst>
          </p:cNvPr>
          <p:cNvSpPr txBox="1"/>
          <p:nvPr/>
        </p:nvSpPr>
        <p:spPr>
          <a:xfrm>
            <a:off x="4557669" y="714647"/>
            <a:ext cx="330539" cy="33041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>
              <a:lnSpc>
                <a:spcPts val="940"/>
              </a:lnSpc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b</a:t>
            </a:r>
          </a:p>
          <a:p>
            <a:pPr algn="ctr">
              <a:lnSpc>
                <a:spcPts val="940"/>
              </a:lnSpc>
            </a:pPr>
            <a:r>
              <a:rPr lang="en-US" altLang="ja-JP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d</a:t>
            </a:r>
            <a:endParaRPr kumimoji="1" lang="ja-JP" altLang="en-US" sz="12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C5CB84ED-4388-A848-8EA7-0CDD53540379}"/>
              </a:ext>
            </a:extLst>
          </p:cNvPr>
          <p:cNvSpPr txBox="1"/>
          <p:nvPr/>
        </p:nvSpPr>
        <p:spPr>
          <a:xfrm>
            <a:off x="5487795" y="4202861"/>
            <a:ext cx="13596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xis1 58.08%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9575D9BD-BE28-994B-A8D8-44B63BA96F94}"/>
              </a:ext>
            </a:extLst>
          </p:cNvPr>
          <p:cNvSpPr txBox="1"/>
          <p:nvPr/>
        </p:nvSpPr>
        <p:spPr>
          <a:xfrm>
            <a:off x="3443350" y="6649298"/>
            <a:ext cx="1359668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xis2 19.31%</a:t>
            </a:r>
            <a:endParaRPr kumimoji="1" lang="ja-JP" altLang="en-US" sz="160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13164987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297</TotalTime>
  <Words>155</Words>
  <Application>Microsoft Office PowerPoint</Application>
  <PresentationFormat>On-screen Show (4:3)</PresentationFormat>
  <Paragraphs>2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Symbol</vt:lpstr>
      <vt:lpstr>Times New Roman</vt:lpstr>
      <vt:lpstr>Office テーマ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sukahara Takamitsu</dc:creator>
  <cp:lastModifiedBy>MDPI</cp:lastModifiedBy>
  <cp:revision>27</cp:revision>
  <dcterms:created xsi:type="dcterms:W3CDTF">2024-05-01T03:44:05Z</dcterms:created>
  <dcterms:modified xsi:type="dcterms:W3CDTF">2025-01-24T09:15:30Z</dcterms:modified>
</cp:coreProperties>
</file>